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669088" cy="9928225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25" d="100"/>
          <a:sy n="125" d="100"/>
        </p:scale>
        <p:origin x="-114" y="165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87"/>
          <p:cNvSpPr txBox="1">
            <a:spLocks noChangeArrowheads="1"/>
          </p:cNvSpPr>
          <p:nvPr/>
        </p:nvSpPr>
        <p:spPr bwMode="auto">
          <a:xfrm>
            <a:off x="179512" y="3501008"/>
            <a:ext cx="8640960" cy="12003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just"/>
            <a:r>
              <a:rPr lang="fr-FR" altLang="zh-CN" sz="900" b="1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Additional</a:t>
            </a:r>
            <a:r>
              <a:rPr lang="fr-FR" altLang="zh-CN" sz="900" b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file 4:  </a:t>
            </a:r>
            <a:r>
              <a:rPr lang="fr-FR" altLang="zh-CN" sz="900" b="1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Effect</a:t>
            </a:r>
            <a:r>
              <a:rPr lang="fr-FR" altLang="zh-CN" sz="900" b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of </a:t>
            </a:r>
            <a:r>
              <a:rPr lang="fr-FR" altLang="zh-CN" sz="900" b="1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cysteine</a:t>
            </a:r>
            <a:r>
              <a:rPr lang="fr-FR" altLang="zh-CN" sz="900" b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lang="fr-FR" altLang="zh-CN" sz="900" b="1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protease</a:t>
            </a:r>
            <a:r>
              <a:rPr lang="fr-FR" altLang="zh-CN" sz="900" b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lang="fr-FR" altLang="zh-CN" sz="900" b="1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inhibitor</a:t>
            </a:r>
            <a:r>
              <a:rPr lang="fr-FR" altLang="zh-CN" sz="900" b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E-64C on CcCP4 </a:t>
            </a:r>
            <a:r>
              <a:rPr lang="fr-FR" altLang="zh-CN" sz="900" b="1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activity</a:t>
            </a:r>
            <a:r>
              <a:rPr lang="fr-FR" altLang="zh-CN" sz="900" b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. 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The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inhibitory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effect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of the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cysteine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protease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inhibitor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E-64C on the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activity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of CcCP4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was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tested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as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follows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10µL (3.2µg) His-tag purified and 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dialysed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 recombinant HIS-SUMO-CP4 protease was added to 20µl sodium 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formate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 (pH3) 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and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incubated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30 second in a 37°C water-bath.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Then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either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100µM E-64C (Panel A), or 10µM E-64C (Panel B), or 1µM E-64C (Panel C), or no E-64C (Panel D, control),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were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added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immediately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followed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by the addition of 6.7µL BSA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reaction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buffer (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see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methods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section). For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each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reaction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, 3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ul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samples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were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taken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at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the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start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(T=0), and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at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T=5min, T=10min, T=3h, T=4h30, and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immediately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added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to 5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ul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5x SDS gel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loading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buffer.  The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samples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were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subsequently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run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 on 8-16% SDS-PAGE gels and stained by 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coomassie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fr-FR" sz="900" b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lang="fr-FR" sz="900" b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L</a:t>
            </a:r>
            <a:r>
              <a:rPr lang="en-GB" sz="900" b="1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ane</a:t>
            </a:r>
            <a:r>
              <a:rPr lang="en-GB" sz="900" b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M</a:t>
            </a:r>
            <a:r>
              <a:rPr lang="en-GB" sz="9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, Molecular marker with the sizes shown on the left in </a:t>
            </a:r>
            <a:r>
              <a:rPr lang="en-GB" sz="90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kDa</a:t>
            </a:r>
            <a:r>
              <a:rPr lang="en-GB" sz="9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(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Biorad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Precision Protein™ Standards, 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prestained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).</a:t>
            </a:r>
            <a:endParaRPr lang="en-GB" sz="900" dirty="0" smtClean="0">
              <a:latin typeface="Arial" pitchFamily="34" charset="0"/>
              <a:ea typeface="SimSun" pitchFamily="2" charset="-122"/>
              <a:cs typeface="Arial" pitchFamily="34" charset="0"/>
            </a:endParaRPr>
          </a:p>
          <a:p>
            <a:pPr algn="just"/>
            <a:endParaRPr lang="fr-FR" sz="900" dirty="0" smtClean="0">
              <a:latin typeface="Arial" pitchFamily="34" charset="0"/>
              <a:cs typeface="Arial" pitchFamily="34" charset="0"/>
            </a:endParaRPr>
          </a:p>
          <a:p>
            <a:pPr algn="just"/>
            <a:endParaRPr lang="fr-FR" sz="900" dirty="0" smtClean="0">
              <a:solidFill>
                <a:srgbClr val="0070C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07504" y="692696"/>
            <a:ext cx="8642891" cy="24322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7" name="ZoneTexte 46"/>
          <p:cNvSpPr txBox="1"/>
          <p:nvPr/>
        </p:nvSpPr>
        <p:spPr>
          <a:xfrm>
            <a:off x="1259632" y="692696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/>
              <a:t>A</a:t>
            </a:r>
            <a:endParaRPr lang="fr-FR" sz="1200" b="1" dirty="0"/>
          </a:p>
        </p:txBody>
      </p:sp>
      <p:sp>
        <p:nvSpPr>
          <p:cNvPr id="48" name="ZoneTexte 47"/>
          <p:cNvSpPr txBox="1"/>
          <p:nvPr/>
        </p:nvSpPr>
        <p:spPr>
          <a:xfrm>
            <a:off x="3275856" y="692696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/>
              <a:t>B</a:t>
            </a:r>
            <a:endParaRPr lang="fr-FR" sz="1200" b="1" dirty="0"/>
          </a:p>
        </p:txBody>
      </p:sp>
      <p:sp>
        <p:nvSpPr>
          <p:cNvPr id="50" name="ZoneTexte 49"/>
          <p:cNvSpPr txBox="1"/>
          <p:nvPr/>
        </p:nvSpPr>
        <p:spPr>
          <a:xfrm>
            <a:off x="5364088" y="692696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/>
              <a:t>C</a:t>
            </a:r>
            <a:endParaRPr lang="fr-FR" sz="1200" b="1" dirty="0"/>
          </a:p>
        </p:txBody>
      </p:sp>
      <p:sp>
        <p:nvSpPr>
          <p:cNvPr id="51" name="ZoneTexte 50"/>
          <p:cNvSpPr txBox="1"/>
          <p:nvPr/>
        </p:nvSpPr>
        <p:spPr>
          <a:xfrm>
            <a:off x="7380312" y="696124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/>
              <a:t>D</a:t>
            </a:r>
            <a:endParaRPr lang="fr-FR" sz="12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4</TotalTime>
  <Words>192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Slide 1</vt:lpstr>
    </vt:vector>
  </TitlesOfParts>
  <Company>Nestlé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RDLepellMa</dc:creator>
  <cp:lastModifiedBy>RDMcCartJa</cp:lastModifiedBy>
  <cp:revision>55</cp:revision>
  <dcterms:created xsi:type="dcterms:W3CDTF">2011-09-27T14:35:25Z</dcterms:created>
  <dcterms:modified xsi:type="dcterms:W3CDTF">2011-11-11T15:22:10Z</dcterms:modified>
</cp:coreProperties>
</file>